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1" r:id="rId4"/>
    <p:sldId id="259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600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912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354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731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323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679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770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616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357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869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226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977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EC925-7D03-4A32-9D20-23E60D5C91FB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2A3EB-969F-4741-A250-58B82E266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163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27379" y="2464082"/>
            <a:ext cx="10515600" cy="1496514"/>
          </a:xfrm>
        </p:spPr>
        <p:txBody>
          <a:bodyPr/>
          <a:lstStyle/>
          <a:p>
            <a:pPr marL="0" indent="0" algn="ctr">
              <a:buNone/>
            </a:pP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Uncut membranes for western blotting</a:t>
            </a:r>
          </a:p>
          <a:p>
            <a:pPr marL="0" indent="0" algn="ctr">
              <a:buNone/>
            </a:pP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apakyriacou et a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8140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21421" y="1519770"/>
            <a:ext cx="2415658" cy="4868677"/>
            <a:chOff x="7125968" y="682187"/>
            <a:chExt cx="2415658" cy="4868677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25968" y="682187"/>
              <a:ext cx="2280903" cy="2410642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7125968" y="812709"/>
              <a:ext cx="2415658" cy="4738155"/>
              <a:chOff x="7125968" y="812709"/>
              <a:chExt cx="2415658" cy="4738155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125968" y="3586033"/>
                <a:ext cx="2247900" cy="1964831"/>
              </a:xfrm>
              <a:prstGeom prst="rect">
                <a:avLst/>
              </a:prstGeom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7695037" y="817459"/>
                <a:ext cx="980450" cy="373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DA231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8159928" y="820081"/>
                <a:ext cx="1066360" cy="373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CC1937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8722259" y="812709"/>
                <a:ext cx="819367" cy="373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T549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7669151" y="1048125"/>
                <a:ext cx="575062" cy="373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947368" y="1036615"/>
                <a:ext cx="558954" cy="373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8192042" y="1032456"/>
                <a:ext cx="575062" cy="373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8429688" y="1035871"/>
                <a:ext cx="558954" cy="373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8680317" y="1038412"/>
                <a:ext cx="575062" cy="373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8915273" y="1036615"/>
                <a:ext cx="558954" cy="373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" name="Straight Connector 16"/>
              <p:cNvCxnSpPr/>
              <p:nvPr/>
            </p:nvCxnSpPr>
            <p:spPr>
              <a:xfrm>
                <a:off x="7794042" y="1037342"/>
                <a:ext cx="324000" cy="502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7923246" y="5246714"/>
                <a:ext cx="7173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8018220" y="2577223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EDD8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Straight Connector 19"/>
              <p:cNvCxnSpPr/>
              <p:nvPr/>
            </p:nvCxnSpPr>
            <p:spPr>
              <a:xfrm>
                <a:off x="8333533" y="1045084"/>
                <a:ext cx="324000" cy="502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>
                <a:off x="8810199" y="1043787"/>
                <a:ext cx="324000" cy="502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2" name="TextBox 21"/>
          <p:cNvSpPr txBox="1"/>
          <p:nvPr/>
        </p:nvSpPr>
        <p:spPr>
          <a:xfrm>
            <a:off x="859132" y="34217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2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2972996" y="1382301"/>
            <a:ext cx="2968111" cy="4052279"/>
            <a:chOff x="354029" y="2312603"/>
            <a:chExt cx="2968111" cy="4052279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95249" y="2312603"/>
              <a:ext cx="2326891" cy="1478124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08610" y="4885387"/>
              <a:ext cx="2200749" cy="1479495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1775819" y="3379078"/>
              <a:ext cx="679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BE2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052139" y="6073290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-act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54031" y="2551130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54030" y="2803098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63345" y="3155692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54029" y="3508286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4229069" y="298726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5" name="Picture 9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86957" y="865747"/>
            <a:ext cx="3348310" cy="2961182"/>
          </a:xfrm>
          <a:prstGeom prst="rect">
            <a:avLst/>
          </a:prstGeom>
        </p:spPr>
      </p:pic>
      <p:sp>
        <p:nvSpPr>
          <p:cNvPr id="96" name="TextBox 95"/>
          <p:cNvSpPr txBox="1"/>
          <p:nvPr/>
        </p:nvSpPr>
        <p:spPr>
          <a:xfrm>
            <a:off x="8755378" y="3502319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DT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8139746" y="342437"/>
            <a:ext cx="833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v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7561741" y="617316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8636917" y="61625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8315834" y="61376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7974473" y="6256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 rot="16200000">
            <a:off x="10120575" y="443894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9062261" y="633470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9435180" y="62910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9685317" y="62691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9978701" y="62263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9406496" y="2907466"/>
            <a:ext cx="1114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  <a:p>
            <a:pPr algn="ctr"/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EDD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9411291" y="347731"/>
            <a:ext cx="833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v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Straight Connector 136"/>
          <p:cNvCxnSpPr/>
          <p:nvPr/>
        </p:nvCxnSpPr>
        <p:spPr>
          <a:xfrm>
            <a:off x="7408693" y="420760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8741770" y="-43585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3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 rot="16200000">
            <a:off x="8726892" y="468882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2" name="Picture 14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39492" y="3826929"/>
            <a:ext cx="3395775" cy="2965152"/>
          </a:xfrm>
          <a:prstGeom prst="rect">
            <a:avLst/>
          </a:prstGeom>
        </p:spPr>
      </p:pic>
      <p:sp>
        <p:nvSpPr>
          <p:cNvPr id="143" name="TextBox 142"/>
          <p:cNvSpPr txBox="1"/>
          <p:nvPr/>
        </p:nvSpPr>
        <p:spPr>
          <a:xfrm>
            <a:off x="8666540" y="6481502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Straight Connector 143"/>
          <p:cNvCxnSpPr/>
          <p:nvPr/>
        </p:nvCxnSpPr>
        <p:spPr>
          <a:xfrm>
            <a:off x="9216353" y="898214"/>
            <a:ext cx="5852" cy="2388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Straight Connector 144"/>
          <p:cNvCxnSpPr/>
          <p:nvPr/>
        </p:nvCxnSpPr>
        <p:spPr>
          <a:xfrm>
            <a:off x="9181134" y="4151539"/>
            <a:ext cx="5852" cy="2388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7916478" y="2907466"/>
            <a:ext cx="1114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7856813" y="5649783"/>
            <a:ext cx="1114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9356682" y="5649783"/>
            <a:ext cx="1114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  <a:p>
            <a:pPr algn="ctr"/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EDD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71135" y="4054284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Lower pa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730699" y="1150438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Higher pa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-67959" y="2213142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-60650" y="239593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-69084" y="265795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-66410" y="304309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-60650" y="319113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-60650" y="364319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-56112" y="347349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-78221" y="475437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-45123" y="496222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-39106" y="521211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-69085" y="554983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-55193" y="573961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-55119" y="618442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-59151" y="600163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090691" y="420879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090690" y="4460764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100005" y="481335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090689" y="516595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157432" y="3571160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Lower pa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4197263" y="981649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Higher pa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6721107" y="164305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88"/>
          <p:cNvCxnSpPr/>
          <p:nvPr/>
        </p:nvCxnSpPr>
        <p:spPr>
          <a:xfrm>
            <a:off x="7194268" y="1789102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7197570" y="123064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7192805" y="1522379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7179621" y="956096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7189868" y="2085992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>
            <a:off x="7200343" y="263584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7196059" y="287760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6665402" y="1106160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6668129" y="1376215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6669282" y="797837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6740075" y="191908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6760664" y="248700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6749804" y="275643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6766558" y="326546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Straight Connector 113"/>
          <p:cNvCxnSpPr/>
          <p:nvPr/>
        </p:nvCxnSpPr>
        <p:spPr>
          <a:xfrm>
            <a:off x="7188963" y="3423671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6761837" y="308311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Straight Connector 115"/>
          <p:cNvCxnSpPr/>
          <p:nvPr/>
        </p:nvCxnSpPr>
        <p:spPr>
          <a:xfrm>
            <a:off x="7195722" y="3241766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>
            <a:off x="7378310" y="7159219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6690724" y="459466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Straight Connector 118"/>
          <p:cNvCxnSpPr/>
          <p:nvPr/>
        </p:nvCxnSpPr>
        <p:spPr>
          <a:xfrm>
            <a:off x="7163885" y="474071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>
            <a:off x="7167187" y="4182262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/>
          <p:nvPr/>
        </p:nvCxnSpPr>
        <p:spPr>
          <a:xfrm>
            <a:off x="7162422" y="447399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7149238" y="3907711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>
            <a:off x="7159485" y="503760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>
            <a:off x="7169960" y="558746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7165676" y="5829222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6635019" y="4057775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6637746" y="4327830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6638899" y="3749452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6709692" y="487069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6730281" y="543861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6719421" y="570805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6736175" y="621708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Straight Connector 132"/>
          <p:cNvCxnSpPr/>
          <p:nvPr/>
        </p:nvCxnSpPr>
        <p:spPr>
          <a:xfrm>
            <a:off x="7158580" y="6375286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6731454" y="603473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Straight Connector 151"/>
          <p:cNvCxnSpPr/>
          <p:nvPr/>
        </p:nvCxnSpPr>
        <p:spPr>
          <a:xfrm>
            <a:off x="7165339" y="6193381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010994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093946" y="860688"/>
            <a:ext cx="3375632" cy="5476886"/>
            <a:chOff x="315956" y="1015311"/>
            <a:chExt cx="3375632" cy="5476886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17051" y="1926796"/>
              <a:ext cx="2674537" cy="222726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 rot="16200000">
              <a:off x="2521067" y="1485163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315956" y="1340528"/>
              <a:ext cx="3071449" cy="2596249"/>
              <a:chOff x="127928" y="263001"/>
              <a:chExt cx="3071449" cy="2596249"/>
            </a:xfrm>
          </p:grpSpPr>
          <p:sp>
            <p:nvSpPr>
              <p:cNvPr id="23" name="TextBox 22"/>
              <p:cNvSpPr txBox="1"/>
              <p:nvPr/>
            </p:nvSpPr>
            <p:spPr>
              <a:xfrm>
                <a:off x="1878897" y="2582251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EDD8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4" name="Group 23"/>
              <p:cNvGrpSpPr/>
              <p:nvPr/>
            </p:nvGrpSpPr>
            <p:grpSpPr>
              <a:xfrm>
                <a:off x="638718" y="1328532"/>
                <a:ext cx="155489" cy="1122876"/>
                <a:chOff x="347957" y="912497"/>
                <a:chExt cx="155489" cy="1122876"/>
              </a:xfrm>
            </p:grpSpPr>
            <p:cxnSp>
              <p:nvCxnSpPr>
                <p:cNvPr id="33" name="Straight Connector 32"/>
                <p:cNvCxnSpPr/>
                <p:nvPr/>
              </p:nvCxnSpPr>
              <p:spPr>
                <a:xfrm>
                  <a:off x="359446" y="912497"/>
                  <a:ext cx="144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/>
                <p:cNvCxnSpPr/>
                <p:nvPr/>
              </p:nvCxnSpPr>
              <p:spPr>
                <a:xfrm>
                  <a:off x="355622" y="1093352"/>
                  <a:ext cx="144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Straight Connector 34"/>
                <p:cNvCxnSpPr/>
                <p:nvPr/>
              </p:nvCxnSpPr>
              <p:spPr>
                <a:xfrm>
                  <a:off x="351480" y="1227209"/>
                  <a:ext cx="144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Connector 35"/>
                <p:cNvCxnSpPr/>
                <p:nvPr/>
              </p:nvCxnSpPr>
              <p:spPr>
                <a:xfrm>
                  <a:off x="347957" y="1497437"/>
                  <a:ext cx="144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Connector 36"/>
                <p:cNvCxnSpPr/>
                <p:nvPr/>
              </p:nvCxnSpPr>
              <p:spPr>
                <a:xfrm>
                  <a:off x="354532" y="1872637"/>
                  <a:ext cx="144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/>
                <p:cNvCxnSpPr/>
                <p:nvPr/>
              </p:nvCxnSpPr>
              <p:spPr>
                <a:xfrm>
                  <a:off x="354532" y="2035373"/>
                  <a:ext cx="144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" name="TextBox 24"/>
              <p:cNvSpPr txBox="1"/>
              <p:nvPr/>
            </p:nvSpPr>
            <p:spPr>
              <a:xfrm rot="16200000">
                <a:off x="2598607" y="375975"/>
                <a:ext cx="44114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</a:t>
                </a:r>
                <a:r>
                  <a:rPr lang="en-U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2818503" y="413043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27928" y="1211318"/>
                <a:ext cx="5693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0 </a:t>
                </a:r>
                <a:r>
                  <a:rPr lang="en-U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143445" y="1383205"/>
                <a:ext cx="5693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205614" y="1517723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</a:t>
                </a:r>
                <a:r>
                  <a:rPr lang="en-U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199039" y="1747388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5 </a:t>
                </a:r>
                <a:r>
                  <a:rPr lang="en-U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05614" y="2139824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 </a:t>
                </a:r>
                <a:r>
                  <a:rPr lang="en-U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99038" y="2330239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 </a:t>
                </a:r>
                <a:r>
                  <a:rPr lang="en-U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 rot="16200000">
              <a:off x="2258175" y="1509878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1914536" y="1480936"/>
              <a:ext cx="7403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0 </a:t>
              </a:r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1115768" y="1432665"/>
              <a:ext cx="7403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ull ctrl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1261254" y="1352090"/>
              <a:ext cx="9043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EDD8 KO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1515736" y="1352091"/>
              <a:ext cx="9043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lank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2431" y="3906501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Straight Connector 13"/>
            <p:cNvCxnSpPr/>
            <p:nvPr/>
          </p:nvCxnSpPr>
          <p:spPr>
            <a:xfrm>
              <a:off x="836624" y="4034502"/>
              <a:ext cx="14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372432" y="3723716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836624" y="3843772"/>
              <a:ext cx="14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1869920" y="1183497"/>
              <a:ext cx="0" cy="709684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2083347" y="1183497"/>
              <a:ext cx="0" cy="709684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Right Triangle 18"/>
            <p:cNvSpPr/>
            <p:nvPr/>
          </p:nvSpPr>
          <p:spPr>
            <a:xfrm>
              <a:off x="2148113" y="1068354"/>
              <a:ext cx="1123875" cy="264535"/>
            </a:xfrm>
            <a:prstGeom prst="rt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88700" y="1157409"/>
              <a:ext cx="8515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vonedistat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83265" y="4368963"/>
              <a:ext cx="2511455" cy="2123234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2136344" y="6174713"/>
              <a:ext cx="717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6699977" y="26027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Group 39"/>
          <p:cNvGrpSpPr/>
          <p:nvPr/>
        </p:nvGrpSpPr>
        <p:grpSpPr>
          <a:xfrm>
            <a:off x="9159129" y="1532143"/>
            <a:ext cx="2707742" cy="4209247"/>
            <a:chOff x="7195791" y="1020552"/>
            <a:chExt cx="2707742" cy="4209247"/>
          </a:xfrm>
        </p:grpSpPr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033988" y="1700297"/>
              <a:ext cx="1842771" cy="2225639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090061" y="4265520"/>
              <a:ext cx="1792794" cy="647705"/>
            </a:xfrm>
            <a:prstGeom prst="rect">
              <a:avLst/>
            </a:prstGeom>
          </p:spPr>
        </p:pic>
        <p:grpSp>
          <p:nvGrpSpPr>
            <p:cNvPr id="43" name="Group 42"/>
            <p:cNvGrpSpPr/>
            <p:nvPr/>
          </p:nvGrpSpPr>
          <p:grpSpPr>
            <a:xfrm>
              <a:off x="7195791" y="1020552"/>
              <a:ext cx="2707742" cy="4209247"/>
              <a:chOff x="7195791" y="1020552"/>
              <a:chExt cx="2707742" cy="4209247"/>
            </a:xfrm>
          </p:grpSpPr>
          <p:sp>
            <p:nvSpPr>
              <p:cNvPr id="44" name="TextBox 43"/>
              <p:cNvSpPr txBox="1"/>
              <p:nvPr/>
            </p:nvSpPr>
            <p:spPr>
              <a:xfrm>
                <a:off x="8640876" y="4009395"/>
                <a:ext cx="64312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EDD8</a:t>
                </a:r>
                <a:endParaRPr 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5" name="Straight Connector 44"/>
              <p:cNvCxnSpPr/>
              <p:nvPr/>
            </p:nvCxnSpPr>
            <p:spPr>
              <a:xfrm>
                <a:off x="7890101" y="1881009"/>
                <a:ext cx="14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>
                <a:off x="7882597" y="2118478"/>
                <a:ext cx="14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/>
              <p:cNvCxnSpPr/>
              <p:nvPr/>
            </p:nvCxnSpPr>
            <p:spPr>
              <a:xfrm>
                <a:off x="7896576" y="2481161"/>
                <a:ext cx="14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/>
              <p:cNvCxnSpPr/>
              <p:nvPr/>
            </p:nvCxnSpPr>
            <p:spPr>
              <a:xfrm>
                <a:off x="7896576" y="3020391"/>
                <a:ext cx="14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9" name="TextBox 48"/>
              <p:cNvSpPr txBox="1"/>
              <p:nvPr/>
            </p:nvSpPr>
            <p:spPr>
              <a:xfrm>
                <a:off x="7195791" y="1721737"/>
                <a:ext cx="65915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7262940" y="1995367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7262126" y="2365441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5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7262126" y="2886034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7299895" y="3154997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7295489" y="3698332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8040576" y="1696901"/>
                <a:ext cx="1849662" cy="224765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6" name="Straight Connector 55"/>
              <p:cNvCxnSpPr/>
              <p:nvPr/>
            </p:nvCxnSpPr>
            <p:spPr>
              <a:xfrm>
                <a:off x="7890755" y="3278108"/>
                <a:ext cx="14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/>
              <p:cNvCxnSpPr/>
              <p:nvPr/>
            </p:nvCxnSpPr>
            <p:spPr>
              <a:xfrm>
                <a:off x="7890344" y="3827946"/>
                <a:ext cx="14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8" name="TextBox 57"/>
              <p:cNvSpPr txBox="1"/>
              <p:nvPr/>
            </p:nvSpPr>
            <p:spPr>
              <a:xfrm>
                <a:off x="8054780" y="1305711"/>
                <a:ext cx="68431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31 </a:t>
                </a:r>
              </a:p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rental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8640876" y="1431619"/>
                <a:ext cx="4111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9011003" y="1426392"/>
                <a:ext cx="6283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8418109" y="1020552"/>
                <a:ext cx="146474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esistance induction</a:t>
                </a:r>
              </a:p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evonedistat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,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2" name="Straight Connector 61"/>
              <p:cNvCxnSpPr/>
              <p:nvPr/>
            </p:nvCxnSpPr>
            <p:spPr>
              <a:xfrm>
                <a:off x="8640876" y="1433593"/>
                <a:ext cx="93597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3" name="Rectangle 62"/>
              <p:cNvSpPr/>
              <p:nvPr/>
            </p:nvSpPr>
            <p:spPr>
              <a:xfrm>
                <a:off x="8090060" y="4261127"/>
                <a:ext cx="1813473" cy="65209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8625795" y="4975883"/>
                <a:ext cx="65915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  <a:endParaRPr 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7273155" y="4718611"/>
                <a:ext cx="65915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0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" name="Straight Connector 65"/>
              <p:cNvCxnSpPr/>
              <p:nvPr/>
            </p:nvCxnSpPr>
            <p:spPr>
              <a:xfrm>
                <a:off x="7919377" y="4855329"/>
                <a:ext cx="14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67" name="TextBox 66"/>
          <p:cNvSpPr txBox="1"/>
          <p:nvPr/>
        </p:nvSpPr>
        <p:spPr>
          <a:xfrm>
            <a:off x="10288854" y="343051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5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Picture 6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84937" y="3948859"/>
            <a:ext cx="3424984" cy="2698595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15417" y="1104040"/>
            <a:ext cx="3388920" cy="2686533"/>
          </a:xfrm>
          <a:prstGeom prst="rect">
            <a:avLst/>
          </a:prstGeom>
        </p:spPr>
      </p:pic>
      <p:sp>
        <p:nvSpPr>
          <p:cNvPr id="70" name="TextBox 69"/>
          <p:cNvSpPr txBox="1"/>
          <p:nvPr/>
        </p:nvSpPr>
        <p:spPr>
          <a:xfrm>
            <a:off x="2444988" y="3482789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DT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299592" y="6278122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743990" y="521078"/>
            <a:ext cx="10789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AK-243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422776" y="790979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146300" y="79306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846575" y="79595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634389" y="80482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6200000">
            <a:off x="1225160" y="642375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851108" y="801801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548836" y="79869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231398" y="80544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2958060" y="80728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rot="16200000">
            <a:off x="2609132" y="639035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178697" y="509831"/>
            <a:ext cx="10789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AK-243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82289" y="189811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86"/>
          <p:cNvCxnSpPr/>
          <p:nvPr/>
        </p:nvCxnSpPr>
        <p:spPr>
          <a:xfrm>
            <a:off x="955450" y="204416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2306078" y="10009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3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509143" y="2805208"/>
            <a:ext cx="1114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983256" y="2805208"/>
            <a:ext cx="1114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  <a:p>
            <a:pPr algn="ctr"/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EDD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/>
          <p:cNvCxnSpPr/>
          <p:nvPr/>
        </p:nvCxnSpPr>
        <p:spPr>
          <a:xfrm>
            <a:off x="2773462" y="1120454"/>
            <a:ext cx="5852" cy="2388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2770536" y="3948859"/>
            <a:ext cx="5852" cy="2388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1412460" y="5604945"/>
            <a:ext cx="1114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912329" y="5604945"/>
            <a:ext cx="1114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  <a:p>
            <a:pPr algn="ctr"/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EDD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5113924" y="1891387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/>
          <p:cNvCxnSpPr/>
          <p:nvPr/>
        </p:nvCxnSpPr>
        <p:spPr>
          <a:xfrm>
            <a:off x="5651041" y="203267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956749" y="153214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953987" y="1777441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953651" y="131288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951050" y="234105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951797" y="2881181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947513" y="3122940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424581" y="140765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429311" y="1631277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443312" y="1154624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501257" y="217414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512118" y="273233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501258" y="300177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510291" y="348764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Straight Connector 109"/>
          <p:cNvCxnSpPr/>
          <p:nvPr/>
        </p:nvCxnSpPr>
        <p:spPr>
          <a:xfrm>
            <a:off x="932696" y="364584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505570" y="330529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Straight Connector 111"/>
          <p:cNvCxnSpPr/>
          <p:nvPr/>
        </p:nvCxnSpPr>
        <p:spPr>
          <a:xfrm>
            <a:off x="939455" y="3463942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461854" y="468286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Straight Connector 113"/>
          <p:cNvCxnSpPr/>
          <p:nvPr/>
        </p:nvCxnSpPr>
        <p:spPr>
          <a:xfrm>
            <a:off x="935015" y="482891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>
            <a:off x="931584" y="4354532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>
            <a:off x="928822" y="4596199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>
            <a:off x="928537" y="410792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>
            <a:off x="925699" y="519999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9" name="Straight Connector 118"/>
          <p:cNvCxnSpPr/>
          <p:nvPr/>
        </p:nvCxnSpPr>
        <p:spPr>
          <a:xfrm>
            <a:off x="952136" y="573111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>
            <a:off x="947852" y="597287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410506" y="4209923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404146" y="4450035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418198" y="3949668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475906" y="503308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512457" y="558226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501597" y="585170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510630" y="633757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Straight Connector 127"/>
          <p:cNvCxnSpPr/>
          <p:nvPr/>
        </p:nvCxnSpPr>
        <p:spPr>
          <a:xfrm>
            <a:off x="933035" y="6495780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505909" y="615522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Straight Connector 129"/>
          <p:cNvCxnSpPr/>
          <p:nvPr/>
        </p:nvCxnSpPr>
        <p:spPr>
          <a:xfrm>
            <a:off x="939794" y="631387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5227671" y="479507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Straight Connector 131"/>
          <p:cNvCxnSpPr/>
          <p:nvPr/>
        </p:nvCxnSpPr>
        <p:spPr>
          <a:xfrm>
            <a:off x="5700832" y="494112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Straight Connector 132"/>
          <p:cNvCxnSpPr/>
          <p:nvPr/>
        </p:nvCxnSpPr>
        <p:spPr>
          <a:xfrm>
            <a:off x="5697401" y="455880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4" name="Straight Connector 133"/>
          <p:cNvCxnSpPr/>
          <p:nvPr/>
        </p:nvCxnSpPr>
        <p:spPr>
          <a:xfrm>
            <a:off x="5703931" y="474855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Straight Connector 134"/>
          <p:cNvCxnSpPr/>
          <p:nvPr/>
        </p:nvCxnSpPr>
        <p:spPr>
          <a:xfrm>
            <a:off x="5694354" y="431219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/>
          <p:nvPr/>
        </p:nvCxnSpPr>
        <p:spPr>
          <a:xfrm>
            <a:off x="5694354" y="519999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Straight Connector 136"/>
          <p:cNvCxnSpPr/>
          <p:nvPr/>
        </p:nvCxnSpPr>
        <p:spPr>
          <a:xfrm>
            <a:off x="5686164" y="559896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Straight Connector 137"/>
          <p:cNvCxnSpPr/>
          <p:nvPr/>
        </p:nvCxnSpPr>
        <p:spPr>
          <a:xfrm>
            <a:off x="5695999" y="578660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5176323" y="4414194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5179255" y="4602393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5184015" y="4153939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5254675" y="506671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5225698" y="547401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5249744" y="566543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5275558" y="613287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6" name="Straight Connector 145"/>
          <p:cNvCxnSpPr/>
          <p:nvPr/>
        </p:nvCxnSpPr>
        <p:spPr>
          <a:xfrm>
            <a:off x="5697963" y="6291082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7" name="TextBox 146"/>
          <p:cNvSpPr txBox="1"/>
          <p:nvPr/>
        </p:nvSpPr>
        <p:spPr>
          <a:xfrm>
            <a:off x="5270837" y="595052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Straight Connector 147"/>
          <p:cNvCxnSpPr/>
          <p:nvPr/>
        </p:nvCxnSpPr>
        <p:spPr>
          <a:xfrm>
            <a:off x="5704722" y="610917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TextBox 148"/>
          <p:cNvSpPr txBox="1"/>
          <p:nvPr/>
        </p:nvSpPr>
        <p:spPr>
          <a:xfrm>
            <a:off x="9223560" y="4963289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Straight Connector 149"/>
          <p:cNvCxnSpPr/>
          <p:nvPr/>
        </p:nvCxnSpPr>
        <p:spPr>
          <a:xfrm>
            <a:off x="9869782" y="510000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9258411" y="4036660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Straight Connector 151"/>
          <p:cNvCxnSpPr/>
          <p:nvPr/>
        </p:nvCxnSpPr>
        <p:spPr>
          <a:xfrm>
            <a:off x="9856849" y="417263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185172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/>
          <p:cNvGrpSpPr/>
          <p:nvPr/>
        </p:nvGrpSpPr>
        <p:grpSpPr>
          <a:xfrm>
            <a:off x="7585471" y="820902"/>
            <a:ext cx="3188057" cy="5423843"/>
            <a:chOff x="6043589" y="765015"/>
            <a:chExt cx="3188057" cy="5423843"/>
          </a:xfrm>
        </p:grpSpPr>
        <p:grpSp>
          <p:nvGrpSpPr>
            <p:cNvPr id="33" name="Group 32"/>
            <p:cNvGrpSpPr/>
            <p:nvPr/>
          </p:nvGrpSpPr>
          <p:grpSpPr>
            <a:xfrm>
              <a:off x="6043589" y="765015"/>
              <a:ext cx="3185507" cy="5318709"/>
              <a:chOff x="7479818" y="884973"/>
              <a:chExt cx="3185507" cy="5318709"/>
            </a:xfrm>
          </p:grpSpPr>
          <p:grpSp>
            <p:nvGrpSpPr>
              <p:cNvPr id="35" name="Group 34"/>
              <p:cNvGrpSpPr/>
              <p:nvPr/>
            </p:nvGrpSpPr>
            <p:grpSpPr>
              <a:xfrm>
                <a:off x="7479818" y="945064"/>
                <a:ext cx="3185507" cy="5258618"/>
                <a:chOff x="7479818" y="945064"/>
                <a:chExt cx="3185507" cy="5258618"/>
              </a:xfrm>
            </p:grpSpPr>
            <p:pic>
              <p:nvPicPr>
                <p:cNvPr id="41" name="Picture 40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8159521" y="2015519"/>
                  <a:ext cx="2346962" cy="1962476"/>
                </a:xfrm>
                <a:prstGeom prst="rect">
                  <a:avLst/>
                </a:prstGeom>
              </p:spPr>
            </p:pic>
            <p:pic>
              <p:nvPicPr>
                <p:cNvPr id="42" name="Picture 41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8079940" y="4202494"/>
                  <a:ext cx="2585385" cy="2001188"/>
                </a:xfrm>
                <a:prstGeom prst="rect">
                  <a:avLst/>
                </a:prstGeom>
              </p:spPr>
            </p:pic>
            <p:grpSp>
              <p:nvGrpSpPr>
                <p:cNvPr id="43" name="Group 42"/>
                <p:cNvGrpSpPr/>
                <p:nvPr/>
              </p:nvGrpSpPr>
              <p:grpSpPr>
                <a:xfrm>
                  <a:off x="7479818" y="945065"/>
                  <a:ext cx="2207954" cy="5256870"/>
                  <a:chOff x="347387" y="1103151"/>
                  <a:chExt cx="2207954" cy="5256870"/>
                </a:xfrm>
              </p:grpSpPr>
              <p:grpSp>
                <p:nvGrpSpPr>
                  <p:cNvPr id="46" name="Group 45"/>
                  <p:cNvGrpSpPr/>
                  <p:nvPr/>
                </p:nvGrpSpPr>
                <p:grpSpPr>
                  <a:xfrm>
                    <a:off x="347387" y="2250982"/>
                    <a:ext cx="2207954" cy="1945200"/>
                    <a:chOff x="159359" y="1173455"/>
                    <a:chExt cx="2207954" cy="1945200"/>
                  </a:xfrm>
                </p:grpSpPr>
                <p:grpSp>
                  <p:nvGrpSpPr>
                    <p:cNvPr id="54" name="Group 53"/>
                    <p:cNvGrpSpPr/>
                    <p:nvPr/>
                  </p:nvGrpSpPr>
                  <p:grpSpPr>
                    <a:xfrm>
                      <a:off x="638718" y="1328532"/>
                      <a:ext cx="155489" cy="1122876"/>
                      <a:chOff x="347957" y="912497"/>
                      <a:chExt cx="155489" cy="1122876"/>
                    </a:xfrm>
                  </p:grpSpPr>
                  <p:cxnSp>
                    <p:nvCxnSpPr>
                      <p:cNvPr id="62" name="Straight Connector 61"/>
                      <p:cNvCxnSpPr/>
                      <p:nvPr/>
                    </p:nvCxnSpPr>
                    <p:spPr>
                      <a:xfrm>
                        <a:off x="359446" y="912497"/>
                        <a:ext cx="144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3" name="Straight Connector 62"/>
                      <p:cNvCxnSpPr/>
                      <p:nvPr/>
                    </p:nvCxnSpPr>
                    <p:spPr>
                      <a:xfrm>
                        <a:off x="355622" y="1093352"/>
                        <a:ext cx="144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4" name="Straight Connector 63"/>
                      <p:cNvCxnSpPr/>
                      <p:nvPr/>
                    </p:nvCxnSpPr>
                    <p:spPr>
                      <a:xfrm>
                        <a:off x="351480" y="1227209"/>
                        <a:ext cx="144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5" name="Straight Connector 64"/>
                      <p:cNvCxnSpPr/>
                      <p:nvPr/>
                    </p:nvCxnSpPr>
                    <p:spPr>
                      <a:xfrm>
                        <a:off x="347957" y="1497437"/>
                        <a:ext cx="144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6" name="Straight Connector 65"/>
                      <p:cNvCxnSpPr/>
                      <p:nvPr/>
                    </p:nvCxnSpPr>
                    <p:spPr>
                      <a:xfrm>
                        <a:off x="354532" y="1872637"/>
                        <a:ext cx="144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7" name="Straight Connector 66"/>
                      <p:cNvCxnSpPr/>
                      <p:nvPr/>
                    </p:nvCxnSpPr>
                    <p:spPr>
                      <a:xfrm>
                        <a:off x="354532" y="2035373"/>
                        <a:ext cx="144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55" name="TextBox 54"/>
                    <p:cNvSpPr txBox="1"/>
                    <p:nvPr/>
                  </p:nvSpPr>
                  <p:spPr>
                    <a:xfrm>
                      <a:off x="162401" y="1173455"/>
                      <a:ext cx="569387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 </a:t>
                      </a:r>
                      <a:r>
                        <a:rPr lang="en-US" sz="8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6" name="TextBox 55"/>
                    <p:cNvSpPr txBox="1"/>
                    <p:nvPr/>
                  </p:nvSpPr>
                  <p:spPr>
                    <a:xfrm>
                      <a:off x="159359" y="1372989"/>
                      <a:ext cx="569387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 </a:t>
                      </a:r>
                      <a:r>
                        <a:rPr lang="en-US" sz="8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7" name="TextBox 56"/>
                    <p:cNvSpPr txBox="1"/>
                    <p:nvPr/>
                  </p:nvSpPr>
                  <p:spPr>
                    <a:xfrm>
                      <a:off x="202562" y="1521036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8" name="TextBox 57"/>
                    <p:cNvSpPr txBox="1"/>
                    <p:nvPr/>
                  </p:nvSpPr>
                  <p:spPr>
                    <a:xfrm>
                      <a:off x="199039" y="1747388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 </a:t>
                      </a:r>
                      <a:r>
                        <a:rPr lang="en-US" sz="8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9" name="TextBox 58"/>
                    <p:cNvSpPr txBox="1"/>
                    <p:nvPr/>
                  </p:nvSpPr>
                  <p:spPr>
                    <a:xfrm>
                      <a:off x="205614" y="2139824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</a:t>
                      </a:r>
                      <a:r>
                        <a:rPr lang="en-US" sz="8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0" name="TextBox 59"/>
                    <p:cNvSpPr txBox="1"/>
                    <p:nvPr/>
                  </p:nvSpPr>
                  <p:spPr>
                    <a:xfrm>
                      <a:off x="199038" y="2330239"/>
                      <a:ext cx="511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</a:t>
                      </a:r>
                      <a:r>
                        <a:rPr lang="en-US" sz="8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1" name="TextBox 60"/>
                    <p:cNvSpPr txBox="1"/>
                    <p:nvPr/>
                  </p:nvSpPr>
                  <p:spPr>
                    <a:xfrm>
                      <a:off x="1230463" y="2872434"/>
                      <a:ext cx="113685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DD8 (EO771)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47" name="TextBox 46"/>
                  <p:cNvSpPr txBox="1"/>
                  <p:nvPr/>
                </p:nvSpPr>
                <p:spPr>
                  <a:xfrm rot="16200000">
                    <a:off x="1320810" y="1642022"/>
                    <a:ext cx="90438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O771 ctrl</a:t>
                    </a:r>
                    <a:endParaRPr 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 rot="16200000">
                    <a:off x="1425911" y="1540976"/>
                    <a:ext cx="110648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O771 N8 KO</a:t>
                    </a:r>
                    <a:endParaRPr 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387065" y="3869907"/>
                    <a:ext cx="51167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 </a:t>
                    </a:r>
                    <a:r>
                      <a:rPr lang="en-US" sz="8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50" name="Straight Connector 49"/>
                  <p:cNvCxnSpPr/>
                  <p:nvPr/>
                </p:nvCxnSpPr>
                <p:spPr>
                  <a:xfrm>
                    <a:off x="849960" y="3981534"/>
                    <a:ext cx="144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376240" y="3709275"/>
                    <a:ext cx="51167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</a:t>
                    </a:r>
                    <a:r>
                      <a:rPr lang="en-US" sz="8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52" name="Straight Connector 51"/>
                  <p:cNvCxnSpPr/>
                  <p:nvPr/>
                </p:nvCxnSpPr>
                <p:spPr>
                  <a:xfrm>
                    <a:off x="836624" y="3843772"/>
                    <a:ext cx="144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1313584" y="6113800"/>
                    <a:ext cx="114967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inculin (EO771)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4" name="TextBox 43"/>
                <p:cNvSpPr txBox="1"/>
                <p:nvPr/>
              </p:nvSpPr>
              <p:spPr>
                <a:xfrm rot="16200000">
                  <a:off x="8890502" y="1483935"/>
                  <a:ext cx="90438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O771 ctrl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 rot="16200000">
                  <a:off x="8995603" y="1382889"/>
                  <a:ext cx="11064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O771 N8 KO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36" name="Straight Connector 35"/>
              <p:cNvCxnSpPr/>
              <p:nvPr/>
            </p:nvCxnSpPr>
            <p:spPr>
              <a:xfrm flipV="1">
                <a:off x="8857311" y="1147156"/>
                <a:ext cx="259190" cy="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 flipV="1">
                <a:off x="9305344" y="1148303"/>
                <a:ext cx="259190" cy="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" name="TextBox 37"/>
              <p:cNvSpPr txBox="1"/>
              <p:nvPr/>
            </p:nvSpPr>
            <p:spPr>
              <a:xfrm>
                <a:off x="8806756" y="8872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9227867" y="884973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4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7853044" y="886705"/>
                <a:ext cx="669418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s in culture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" name="Rectangle 33"/>
            <p:cNvSpPr/>
            <p:nvPr/>
          </p:nvSpPr>
          <p:spPr>
            <a:xfrm>
              <a:off x="8230581" y="1796735"/>
              <a:ext cx="1001065" cy="439212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8" name="TextBox 67"/>
          <p:cNvSpPr txBox="1"/>
          <p:nvPr/>
        </p:nvSpPr>
        <p:spPr>
          <a:xfrm>
            <a:off x="8418618" y="36083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6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Picture 6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06369" y="1642177"/>
            <a:ext cx="2725519" cy="3517752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64808" y="5271557"/>
            <a:ext cx="2767080" cy="1261187"/>
          </a:xfrm>
          <a:prstGeom prst="rect">
            <a:avLst/>
          </a:prstGeom>
        </p:spPr>
      </p:pic>
      <p:sp>
        <p:nvSpPr>
          <p:cNvPr id="71" name="TextBox 70"/>
          <p:cNvSpPr txBox="1"/>
          <p:nvPr/>
        </p:nvSpPr>
        <p:spPr>
          <a:xfrm>
            <a:off x="2568090" y="1088647"/>
            <a:ext cx="12261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AK-243,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3819622" y="1328480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414673" y="132919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628112" y="13284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052381" y="1336324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270530" y="854993"/>
            <a:ext cx="16482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, Ctr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994649" y="133632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2767461" y="4852152"/>
            <a:ext cx="654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AE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689747" y="5574801"/>
            <a:ext cx="809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569685" y="360833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5I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833298" y="214004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86"/>
          <p:cNvCxnSpPr/>
          <p:nvPr/>
        </p:nvCxnSpPr>
        <p:spPr>
          <a:xfrm>
            <a:off x="1306459" y="228609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1300266" y="194480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1317712" y="588852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1314874" y="281657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1311442" y="3665236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1318018" y="394803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804443" y="616009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775590" y="1798644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807373" y="5730265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865081" y="264966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871763" y="351638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871763" y="382686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871763" y="464262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Straight Connector 100"/>
          <p:cNvCxnSpPr/>
          <p:nvPr/>
        </p:nvCxnSpPr>
        <p:spPr>
          <a:xfrm>
            <a:off x="1294168" y="4800830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871763" y="439592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02"/>
          <p:cNvCxnSpPr/>
          <p:nvPr/>
        </p:nvCxnSpPr>
        <p:spPr>
          <a:xfrm>
            <a:off x="1305648" y="455457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1314874" y="629907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8077781" y="201306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7567442" y="1854808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7559726" y="463228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Straight Connector 107"/>
          <p:cNvCxnSpPr/>
          <p:nvPr/>
        </p:nvCxnSpPr>
        <p:spPr>
          <a:xfrm>
            <a:off x="8032887" y="4778331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8027611" y="4418369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8036533" y="460519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>
            <a:off x="8015856" y="422337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>
            <a:off x="8046692" y="502065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8047781" y="536952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/>
          <p:nvPr/>
        </p:nvCxnSpPr>
        <p:spPr>
          <a:xfrm>
            <a:off x="8049883" y="554186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7495443" y="4293882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7511857" y="4459029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7505517" y="406511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7596899" y="485374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7608102" y="522067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7603628" y="542069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7613016" y="583355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Straight Connector 121"/>
          <p:cNvCxnSpPr/>
          <p:nvPr/>
        </p:nvCxnSpPr>
        <p:spPr>
          <a:xfrm>
            <a:off x="8035421" y="5991760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7608295" y="565120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Straight Connector 123"/>
          <p:cNvCxnSpPr/>
          <p:nvPr/>
        </p:nvCxnSpPr>
        <p:spPr>
          <a:xfrm>
            <a:off x="8042180" y="580985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381331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5057" y="1118044"/>
            <a:ext cx="1967973" cy="226857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773398" y="2703829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ullin-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22725" y="263049"/>
            <a:ext cx="1967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vonedistat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35677" y="3414247"/>
            <a:ext cx="2014015" cy="228669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8576244" y="86359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302901" y="87100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790693" y="8635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582290" y="86359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513601" y="613344"/>
            <a:ext cx="16482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, Ctr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009540" y="86911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790693" y="5339406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50823" y="1129282"/>
            <a:ext cx="1984870" cy="2210207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10703031" y="861655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0429688" y="86906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917480" y="86165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709077" y="861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9640388" y="611401"/>
            <a:ext cx="16289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, KO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136327" y="86717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35292" y="3402362"/>
            <a:ext cx="2034068" cy="2273370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9861893" y="5337955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9839849" y="270083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ullin-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756033" y="263049"/>
            <a:ext cx="1526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AK-243,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Picture 6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03064" y="858761"/>
            <a:ext cx="3028949" cy="2522183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>
            <a:off x="3072964" y="1129282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799621" y="113668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287413" y="112928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079010" y="11292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010321" y="879028"/>
            <a:ext cx="16482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, Ctr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506260" y="113479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410086" y="1602144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4136743" y="160954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624535" y="16021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416132" y="160214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843382" y="160765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286381" y="1812075"/>
            <a:ext cx="16289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, KO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876451" y="2970158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ullin-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Picture 8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01314" y="3738543"/>
            <a:ext cx="3085681" cy="2522183"/>
          </a:xfrm>
          <a:prstGeom prst="rect">
            <a:avLst/>
          </a:prstGeom>
        </p:spPr>
      </p:pic>
      <p:sp>
        <p:nvSpPr>
          <p:cNvPr id="86" name="TextBox 85"/>
          <p:cNvSpPr txBox="1"/>
          <p:nvPr/>
        </p:nvSpPr>
        <p:spPr>
          <a:xfrm>
            <a:off x="3012779" y="3739470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739436" y="374687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227228" y="373947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018825" y="373947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950136" y="3489216"/>
            <a:ext cx="16482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, Ctr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2446075" y="374498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387341" y="4146889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113998" y="415429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601790" y="41468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3393387" y="41468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3820637" y="415240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3263636" y="4356820"/>
            <a:ext cx="16289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DA-MB-231, KO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3012779" y="5850272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404461" y="109521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146292" y="155067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04"/>
          <p:cNvCxnSpPr/>
          <p:nvPr/>
        </p:nvCxnSpPr>
        <p:spPr>
          <a:xfrm>
            <a:off x="1619453" y="1696726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1635291" y="113696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>
            <a:off x="1627799" y="145126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1632193" y="91770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1625617" y="207547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1631939" y="2596720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>
            <a:off x="1627655" y="2838479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1103123" y="1012480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103123" y="1305104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121854" y="759448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175824" y="190856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192260" y="244787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181400" y="271731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175824" y="309168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Straight Connector 120"/>
          <p:cNvCxnSpPr/>
          <p:nvPr/>
        </p:nvCxnSpPr>
        <p:spPr>
          <a:xfrm>
            <a:off x="1609709" y="325033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1021252" y="443685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Straight Connector 123"/>
          <p:cNvCxnSpPr/>
          <p:nvPr/>
        </p:nvCxnSpPr>
        <p:spPr>
          <a:xfrm>
            <a:off x="1494413" y="458290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1510251" y="402314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>
            <a:off x="1502759" y="4337446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>
            <a:off x="1507153" y="380388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>
            <a:off x="1500577" y="496165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Straight Connector 128"/>
          <p:cNvCxnSpPr/>
          <p:nvPr/>
        </p:nvCxnSpPr>
        <p:spPr>
          <a:xfrm>
            <a:off x="1506899" y="548289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Straight Connector 129"/>
          <p:cNvCxnSpPr/>
          <p:nvPr/>
        </p:nvCxnSpPr>
        <p:spPr>
          <a:xfrm>
            <a:off x="1502615" y="572465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978083" y="3898658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978083" y="4191282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996814" y="364562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050784" y="479474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1067220" y="533405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1056360" y="560348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1050784" y="597786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Straight Connector 137"/>
          <p:cNvCxnSpPr/>
          <p:nvPr/>
        </p:nvCxnSpPr>
        <p:spPr>
          <a:xfrm>
            <a:off x="1484669" y="613651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6572784" y="186544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Straight Connector 139"/>
          <p:cNvCxnSpPr/>
          <p:nvPr/>
        </p:nvCxnSpPr>
        <p:spPr>
          <a:xfrm>
            <a:off x="7045945" y="2011494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Straight Connector 140"/>
          <p:cNvCxnSpPr/>
          <p:nvPr/>
        </p:nvCxnSpPr>
        <p:spPr>
          <a:xfrm>
            <a:off x="7061783" y="145173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Straight Connector 141"/>
          <p:cNvCxnSpPr/>
          <p:nvPr/>
        </p:nvCxnSpPr>
        <p:spPr>
          <a:xfrm>
            <a:off x="7054291" y="1766036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/>
          <p:nvPr/>
        </p:nvCxnSpPr>
        <p:spPr>
          <a:xfrm>
            <a:off x="7058685" y="123247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4" name="Straight Connector 143"/>
          <p:cNvCxnSpPr/>
          <p:nvPr/>
        </p:nvCxnSpPr>
        <p:spPr>
          <a:xfrm>
            <a:off x="7037116" y="2324453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Straight Connector 144"/>
          <p:cNvCxnSpPr/>
          <p:nvPr/>
        </p:nvCxnSpPr>
        <p:spPr>
          <a:xfrm>
            <a:off x="7000481" y="2758436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6" name="Straight Connector 145"/>
          <p:cNvCxnSpPr/>
          <p:nvPr/>
        </p:nvCxnSpPr>
        <p:spPr>
          <a:xfrm>
            <a:off x="6996197" y="300019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7" name="TextBox 146"/>
          <p:cNvSpPr txBox="1"/>
          <p:nvPr/>
        </p:nvSpPr>
        <p:spPr>
          <a:xfrm>
            <a:off x="6529615" y="1327248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6529615" y="1619872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6548346" y="107421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6587323" y="215754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6560802" y="260958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6549942" y="287902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6509686" y="418873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2" name="Straight Connector 171"/>
          <p:cNvCxnSpPr/>
          <p:nvPr/>
        </p:nvCxnSpPr>
        <p:spPr>
          <a:xfrm>
            <a:off x="6982847" y="433477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3" name="Straight Connector 172"/>
          <p:cNvCxnSpPr/>
          <p:nvPr/>
        </p:nvCxnSpPr>
        <p:spPr>
          <a:xfrm>
            <a:off x="6998685" y="3775019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4" name="Straight Connector 173"/>
          <p:cNvCxnSpPr/>
          <p:nvPr/>
        </p:nvCxnSpPr>
        <p:spPr>
          <a:xfrm>
            <a:off x="6991193" y="4089320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5" name="Straight Connector 174"/>
          <p:cNvCxnSpPr/>
          <p:nvPr/>
        </p:nvCxnSpPr>
        <p:spPr>
          <a:xfrm>
            <a:off x="6995587" y="3555759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6" name="Straight Connector 175"/>
          <p:cNvCxnSpPr/>
          <p:nvPr/>
        </p:nvCxnSpPr>
        <p:spPr>
          <a:xfrm>
            <a:off x="6974018" y="4647737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7" name="Straight Connector 176"/>
          <p:cNvCxnSpPr/>
          <p:nvPr/>
        </p:nvCxnSpPr>
        <p:spPr>
          <a:xfrm>
            <a:off x="6958064" y="5123118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8" name="Straight Connector 177"/>
          <p:cNvCxnSpPr/>
          <p:nvPr/>
        </p:nvCxnSpPr>
        <p:spPr>
          <a:xfrm>
            <a:off x="6945210" y="5372895"/>
            <a:ext cx="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TextBox 178"/>
          <p:cNvSpPr txBox="1"/>
          <p:nvPr/>
        </p:nvSpPr>
        <p:spPr>
          <a:xfrm>
            <a:off x="6466517" y="3650532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6466517" y="394315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6485248" y="3397500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6524225" y="448082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6518385" y="497427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6498955" y="525172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6339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513</Words>
  <Application>Microsoft Office PowerPoint</Application>
  <PresentationFormat>Widescreen</PresentationFormat>
  <Paragraphs>29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ppsala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meng Mao</dc:creator>
  <cp:lastModifiedBy>Yumeng Mao</cp:lastModifiedBy>
  <cp:revision>18</cp:revision>
  <dcterms:created xsi:type="dcterms:W3CDTF">2023-03-03T08:34:08Z</dcterms:created>
  <dcterms:modified xsi:type="dcterms:W3CDTF">2024-04-01T20:35:32Z</dcterms:modified>
</cp:coreProperties>
</file>